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5" d="100"/>
          <a:sy n="85" d="100"/>
        </p:scale>
        <p:origin x="74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DD9FFFA-5282-B079-AAB8-7943560FEA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03CD481-F484-75DB-44B1-1B8DD8A383A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CA14492-4FD5-469F-A03E-21F48FA59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8F3C8-BD08-4D2F-AD92-8C38C0C2755B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040AFAC-E0B7-506C-E8D2-B25B624CBA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2C5A38E-5D77-6DAA-A6A8-900C9A1E8E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1C069-2C6B-4986-A05B-EFE65F2AA7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8182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279820-DCEE-2596-F78B-FEAA04EFD9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7E7D2B9-7DA6-BEBF-79A6-8E9D436C9B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0976A21-D1E8-423D-1CD9-7C780A6605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8F3C8-BD08-4D2F-AD92-8C38C0C2755B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2A48353-4CD9-9C53-D3E8-D7C8EE9468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6EB4F0F-23C3-3D76-62A9-177D08C167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1C069-2C6B-4986-A05B-EFE65F2AA7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5304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FD078F3-21A1-6B39-B5F2-F0C182D05E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EDF11C9-BD66-E63B-94F0-56DD600C5A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E591433-F5BA-5EE2-E671-61E4A44C45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8F3C8-BD08-4D2F-AD92-8C38C0C2755B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D2C8B5-CD1E-0738-AC62-C71ECE1CCC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EDACD55-8260-E68A-F0F7-6AD023B687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1C069-2C6B-4986-A05B-EFE65F2AA7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9820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34E3E0A-0E7F-92B2-AA27-8849826269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C7C6291-8E48-E813-D761-87FE6470E3F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02FE21D-16AB-A7BF-5834-D091197A3C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8F3C8-BD08-4D2F-AD92-8C38C0C2755B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62299D6-8469-E044-1CB6-AE5E142C74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EF462F4-291B-3E67-ACFD-C87A21121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1C069-2C6B-4986-A05B-EFE65F2AA7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3659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EB83ED-0BC1-4FCF-3A07-39BACC7B18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90490A8-1881-8706-3679-E2F7BAF202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5146511-BF2B-82CF-D811-076C3FE214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8F3C8-BD08-4D2F-AD92-8C38C0C2755B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FE68BA0-F452-1F5C-1A4C-32DA504F22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7452DA7-6FBB-4B47-238A-99A2919792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1C069-2C6B-4986-A05B-EFE65F2AA7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06148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C6B1E3-FD42-1D11-F2D7-82009B7C95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FD1932F-B3CE-6789-6215-6D7B6A73464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CB3DBF6-9448-9665-8711-9B2E2E3451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39C337F-367D-8C1A-603E-71B6931763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8F3C8-BD08-4D2F-AD92-8C38C0C2755B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CF10AA4-C3D8-0A9A-FB74-ECC2CD7A6C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7D547DE-1BE8-8F0F-E473-4778D09B9C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1C069-2C6B-4986-A05B-EFE65F2AA7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01656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747BB34-A846-CAF2-FCD9-6262FC73DB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17D32FA-655D-0838-86B0-BCECD9FA90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3EC6A7F-7E0F-999D-ACD4-329B870A22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651E2B2-0E48-7E95-FD03-9935DB10CD5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EF3E65F-ED51-E8D9-7DA0-0A4ACC2013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7AB869D-A462-7056-D8B8-9E086FBA0E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8F3C8-BD08-4D2F-AD92-8C38C0C2755B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8848DED-F52B-B289-62A6-C941370390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99E8BA1-7B40-C631-80DC-243DEC356A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1C069-2C6B-4986-A05B-EFE65F2AA7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64663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98794E-A798-6747-B041-0AFBF41CCD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6CF2BB6-D68F-1752-69C5-CCD6761810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8F3C8-BD08-4D2F-AD92-8C38C0C2755B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3B21701-B8E6-CF79-1890-3FE2C151F8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E69565B-868B-983C-FD8B-D894645DD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1C069-2C6B-4986-A05B-EFE65F2AA7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08104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5F96E2B-9F22-2CB4-CEFD-B1972A73ED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8F3C8-BD08-4D2F-AD92-8C38C0C2755B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9EB1F6C-02BF-7142-C8A1-F83E88DB4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9BABBEA-35D3-290E-9933-F353A4CABF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1C069-2C6B-4986-A05B-EFE65F2AA7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7701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7BF0CFD-7803-7092-95A5-DEA2E4ABBC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6428215-B976-57F5-5FB0-1BF41A7BC0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9914A23-0FA0-1D4B-B195-B996E9898A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121F33D-C5B9-0304-A610-85146AEB36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8F3C8-BD08-4D2F-AD92-8C38C0C2755B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4ACC45D-707A-1EA2-6A0F-B5C8DB1BB3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23A63D8-6B64-F304-CE0E-57872CA3B8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1C069-2C6B-4986-A05B-EFE65F2AA7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266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87BDB0-2124-AFC4-FF9B-ECAE4A1B40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7977AE7-C6E0-043F-2816-2260E8A34D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32F6983-A29F-D23B-112D-34A7F244B9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6A5C0B7-054D-87B8-FC9F-53AC2CCDC0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8F3C8-BD08-4D2F-AD92-8C38C0C2755B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0B98C6E-A5BB-384D-3660-710F844D2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A6DE608-3B96-FFED-EB59-2DC4BC3B74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1C069-2C6B-4986-A05B-EFE65F2AA7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22585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7306B04-D345-B0D5-8034-D567FBB7CC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16D742A-1C54-180B-EC0B-2E37F1BCD9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FBBD197-6285-1681-FF4F-BB04286050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58F3C8-BD08-4D2F-AD92-8C38C0C2755B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ED5039D-945B-43F7-51F5-9B5FD6E8D14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7EF2E38-640C-CB77-7F7A-74B7E45AB2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01C069-2C6B-4986-A05B-EFE65F2AA7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756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组合 33">
            <a:extLst>
              <a:ext uri="{FF2B5EF4-FFF2-40B4-BE49-F238E27FC236}">
                <a16:creationId xmlns:a16="http://schemas.microsoft.com/office/drawing/2014/main" id="{69506020-056B-C704-43F7-459F376ECA3A}"/>
              </a:ext>
            </a:extLst>
          </p:cNvPr>
          <p:cNvGrpSpPr/>
          <p:nvPr/>
        </p:nvGrpSpPr>
        <p:grpSpPr>
          <a:xfrm>
            <a:off x="3787421" y="578555"/>
            <a:ext cx="5090994" cy="3226505"/>
            <a:chOff x="3787421" y="578555"/>
            <a:chExt cx="5090994" cy="3226505"/>
          </a:xfrm>
          <a:effectLst>
            <a:outerShdw blurRad="63500" sx="102000" sy="102000" algn="ctr" rotWithShape="0">
              <a:prstClr val="black">
                <a:alpha val="40000"/>
              </a:prstClr>
            </a:outerShdw>
          </a:effectLst>
        </p:grpSpPr>
        <p:sp>
          <p:nvSpPr>
            <p:cNvPr id="5" name="矩形: 圆角 4">
              <a:extLst>
                <a:ext uri="{FF2B5EF4-FFF2-40B4-BE49-F238E27FC236}">
                  <a16:creationId xmlns:a16="http://schemas.microsoft.com/office/drawing/2014/main" id="{42B6E6E0-089D-5CD6-F24A-D0C471AFB1D5}"/>
                </a:ext>
              </a:extLst>
            </p:cNvPr>
            <p:cNvSpPr/>
            <p:nvPr/>
          </p:nvSpPr>
          <p:spPr>
            <a:xfrm>
              <a:off x="5554132" y="578555"/>
              <a:ext cx="1264356" cy="553156"/>
            </a:xfrm>
            <a:prstGeom prst="roundRect">
              <a:avLst/>
            </a:prstGeom>
            <a:ln>
              <a:solidFill>
                <a:srgbClr val="002060"/>
              </a:solidFill>
            </a:ln>
            <a:scene3d>
              <a:camera prst="orthographicFront"/>
              <a:lightRig rig="threePt" dir="t"/>
            </a:scene3d>
            <a:sp3d>
              <a:bevelT prst="relaxedInset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nvironment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E138BEFB-69D5-6D85-DE3D-D15A0C39E35E}"/>
                </a:ext>
              </a:extLst>
            </p:cNvPr>
            <p:cNvSpPr/>
            <p:nvPr/>
          </p:nvSpPr>
          <p:spPr>
            <a:xfrm>
              <a:off x="4247444" y="1794933"/>
              <a:ext cx="1027289" cy="553156"/>
            </a:xfrm>
            <a:prstGeom prst="rect">
              <a:avLst/>
            </a:prstGeom>
            <a:solidFill>
              <a:schemeClr val="accent4"/>
            </a:solidFill>
            <a:ln>
              <a:solidFill>
                <a:srgbClr val="002060"/>
              </a:solidFill>
            </a:ln>
            <a:scene3d>
              <a:camera prst="orthographicFront"/>
              <a:lightRig rig="threePt" dir="t"/>
            </a:scene3d>
            <a:sp3d>
              <a:bevelT w="139700" prst="cross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b="0" i="0" u="none" strike="noStrike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nformation fusion</a:t>
              </a:r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8135B676-DD1E-09DA-B17D-B1A307ED1931}"/>
                </a:ext>
              </a:extLst>
            </p:cNvPr>
            <p:cNvSpPr/>
            <p:nvPr/>
          </p:nvSpPr>
          <p:spPr>
            <a:xfrm>
              <a:off x="7097888" y="1794933"/>
              <a:ext cx="1027289" cy="553156"/>
            </a:xfrm>
            <a:prstGeom prst="rect">
              <a:avLst/>
            </a:prstGeom>
            <a:solidFill>
              <a:schemeClr val="accent4"/>
            </a:solidFill>
            <a:ln>
              <a:solidFill>
                <a:srgbClr val="002060"/>
              </a:solidFill>
            </a:ln>
            <a:scene3d>
              <a:camera prst="orthographicFront"/>
              <a:lightRig rig="threePt" dir="t"/>
            </a:scene3d>
            <a:sp3d>
              <a:bevelT w="139700" prst="cross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tion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5E525F47-D6EE-67F9-0AF4-062924254010}"/>
                </a:ext>
              </a:extLst>
            </p:cNvPr>
            <p:cNvSpPr/>
            <p:nvPr/>
          </p:nvSpPr>
          <p:spPr>
            <a:xfrm>
              <a:off x="5672666" y="1794933"/>
              <a:ext cx="1027289" cy="553156"/>
            </a:xfrm>
            <a:prstGeom prst="rect">
              <a:avLst/>
            </a:prstGeom>
            <a:solidFill>
              <a:schemeClr val="accent4"/>
            </a:solidFill>
            <a:ln>
              <a:solidFill>
                <a:srgbClr val="002060"/>
              </a:solidFill>
            </a:ln>
            <a:scene3d>
              <a:camera prst="orthographicFront"/>
              <a:lightRig rig="threePt" dir="t"/>
            </a:scene3d>
            <a:sp3d>
              <a:bevelT w="139700" prst="cross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lan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59808386-FB3B-4238-CE1F-524E0EAB0390}"/>
                </a:ext>
              </a:extLst>
            </p:cNvPr>
            <p:cNvSpPr/>
            <p:nvPr/>
          </p:nvSpPr>
          <p:spPr>
            <a:xfrm>
              <a:off x="7097888" y="2923822"/>
              <a:ext cx="1027289" cy="553156"/>
            </a:xfrm>
            <a:prstGeom prst="rect">
              <a:avLst/>
            </a:prstGeom>
            <a:solidFill>
              <a:srgbClr val="FFC000"/>
            </a:solidFill>
            <a:ln>
              <a:solidFill>
                <a:srgbClr val="002060"/>
              </a:solidFill>
            </a:ln>
            <a:scene3d>
              <a:camera prst="orthographicFront"/>
              <a:lightRig rig="threePt" dir="t"/>
            </a:scene3d>
            <a:sp3d>
              <a:bevelT w="114300" prst="hardEdge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rget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C29C7BD3-D340-6F40-1541-CCB955425AD0}"/>
                </a:ext>
              </a:extLst>
            </p:cNvPr>
            <p:cNvSpPr/>
            <p:nvPr/>
          </p:nvSpPr>
          <p:spPr>
            <a:xfrm>
              <a:off x="5672666" y="2923822"/>
              <a:ext cx="1027289" cy="553156"/>
            </a:xfrm>
            <a:prstGeom prst="rect">
              <a:avLst/>
            </a:prstGeom>
            <a:solidFill>
              <a:srgbClr val="FFC000"/>
            </a:solidFill>
            <a:ln>
              <a:solidFill>
                <a:srgbClr val="002060"/>
              </a:solidFill>
            </a:ln>
            <a:scene3d>
              <a:camera prst="orthographicFront"/>
              <a:lightRig rig="threePt" dir="t"/>
            </a:scene3d>
            <a:sp3d>
              <a:bevelT w="114300" prst="hardEdge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</a:t>
              </a:r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owledge base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E3FA7713-2136-FBA8-937E-FD50DC6A8EAB}"/>
                </a:ext>
              </a:extLst>
            </p:cNvPr>
            <p:cNvSpPr/>
            <p:nvPr/>
          </p:nvSpPr>
          <p:spPr>
            <a:xfrm>
              <a:off x="4247150" y="2923822"/>
              <a:ext cx="1027289" cy="553156"/>
            </a:xfrm>
            <a:prstGeom prst="rect">
              <a:avLst/>
            </a:prstGeom>
            <a:solidFill>
              <a:srgbClr val="FFC000"/>
            </a:solidFill>
            <a:ln>
              <a:solidFill>
                <a:srgbClr val="002060"/>
              </a:solidFill>
            </a:ln>
            <a:scene3d>
              <a:camera prst="orthographicFront"/>
              <a:lightRig rig="threePt" dir="t"/>
            </a:scene3d>
            <a:sp3d>
              <a:bevelT w="114300" prst="hardEdge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nal state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" name="直接箭头连接符 12">
              <a:extLst>
                <a:ext uri="{FF2B5EF4-FFF2-40B4-BE49-F238E27FC236}">
                  <a16:creationId xmlns:a16="http://schemas.microsoft.com/office/drawing/2014/main" id="{E9532EDC-D85A-A8B4-1BCA-976367C5CC66}"/>
                </a:ext>
              </a:extLst>
            </p:cNvPr>
            <p:cNvCxnSpPr>
              <a:stCxn id="11" idx="0"/>
              <a:endCxn id="6" idx="2"/>
            </p:cNvCxnSpPr>
            <p:nvPr/>
          </p:nvCxnSpPr>
          <p:spPr>
            <a:xfrm flipV="1">
              <a:off x="4760795" y="2348089"/>
              <a:ext cx="294" cy="575733"/>
            </a:xfrm>
            <a:prstGeom prst="straightConnector1">
              <a:avLst/>
            </a:prstGeom>
            <a:ln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接箭头连接符 14">
              <a:extLst>
                <a:ext uri="{FF2B5EF4-FFF2-40B4-BE49-F238E27FC236}">
                  <a16:creationId xmlns:a16="http://schemas.microsoft.com/office/drawing/2014/main" id="{9269DE69-4B36-DCB7-8792-FBC853B0BF77}"/>
                </a:ext>
              </a:extLst>
            </p:cNvPr>
            <p:cNvCxnSpPr>
              <a:stCxn id="10" idx="0"/>
              <a:endCxn id="8" idx="2"/>
            </p:cNvCxnSpPr>
            <p:nvPr/>
          </p:nvCxnSpPr>
          <p:spPr>
            <a:xfrm flipV="1">
              <a:off x="6186311" y="2348089"/>
              <a:ext cx="0" cy="575733"/>
            </a:xfrm>
            <a:prstGeom prst="straightConnector1">
              <a:avLst/>
            </a:prstGeom>
            <a:ln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接箭头连接符 16">
              <a:extLst>
                <a:ext uri="{FF2B5EF4-FFF2-40B4-BE49-F238E27FC236}">
                  <a16:creationId xmlns:a16="http://schemas.microsoft.com/office/drawing/2014/main" id="{C7D7E401-D4DC-6842-C75E-7CE6D2EA2AB0}"/>
                </a:ext>
              </a:extLst>
            </p:cNvPr>
            <p:cNvCxnSpPr>
              <a:stCxn id="9" idx="0"/>
              <a:endCxn id="7" idx="2"/>
            </p:cNvCxnSpPr>
            <p:nvPr/>
          </p:nvCxnSpPr>
          <p:spPr>
            <a:xfrm flipV="1">
              <a:off x="7611533" y="2348089"/>
              <a:ext cx="0" cy="575733"/>
            </a:xfrm>
            <a:prstGeom prst="straightConnector1">
              <a:avLst/>
            </a:prstGeom>
            <a:ln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83E729A9-59D8-5FC6-43B2-83183575E22C}"/>
                </a:ext>
              </a:extLst>
            </p:cNvPr>
            <p:cNvSpPr/>
            <p:nvPr/>
          </p:nvSpPr>
          <p:spPr>
            <a:xfrm>
              <a:off x="3787421" y="1466849"/>
              <a:ext cx="4797778" cy="2338211"/>
            </a:xfrm>
            <a:prstGeom prst="rect">
              <a:avLst/>
            </a:prstGeom>
            <a:noFill/>
            <a:ln>
              <a:solidFill>
                <a:srgbClr val="002060"/>
              </a:solidFill>
              <a:prstDash val="dash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" name="连接符: 肘形 19">
              <a:extLst>
                <a:ext uri="{FF2B5EF4-FFF2-40B4-BE49-F238E27FC236}">
                  <a16:creationId xmlns:a16="http://schemas.microsoft.com/office/drawing/2014/main" id="{4A0D5876-3A9E-271B-B102-E65F7A324AA5}"/>
                </a:ext>
              </a:extLst>
            </p:cNvPr>
            <p:cNvCxnSpPr>
              <a:stCxn id="5" idx="1"/>
              <a:endCxn id="6" idx="0"/>
            </p:cNvCxnSpPr>
            <p:nvPr/>
          </p:nvCxnSpPr>
          <p:spPr>
            <a:xfrm rot="10800000" flipV="1">
              <a:off x="4761090" y="855133"/>
              <a:ext cx="793043" cy="939800"/>
            </a:xfrm>
            <a:prstGeom prst="bentConnector2">
              <a:avLst/>
            </a:prstGeom>
            <a:ln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连接符: 肘形 21">
              <a:extLst>
                <a:ext uri="{FF2B5EF4-FFF2-40B4-BE49-F238E27FC236}">
                  <a16:creationId xmlns:a16="http://schemas.microsoft.com/office/drawing/2014/main" id="{3203E1AE-8142-027E-B487-227CAEBFA449}"/>
                </a:ext>
              </a:extLst>
            </p:cNvPr>
            <p:cNvCxnSpPr>
              <a:cxnSpLocks/>
              <a:stCxn id="7" idx="0"/>
              <a:endCxn id="5" idx="3"/>
            </p:cNvCxnSpPr>
            <p:nvPr/>
          </p:nvCxnSpPr>
          <p:spPr>
            <a:xfrm rot="16200000" flipV="1">
              <a:off x="6745111" y="928510"/>
              <a:ext cx="939800" cy="793045"/>
            </a:xfrm>
            <a:prstGeom prst="bentConnector2">
              <a:avLst/>
            </a:prstGeom>
            <a:ln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接箭头连接符 24">
              <a:extLst>
                <a:ext uri="{FF2B5EF4-FFF2-40B4-BE49-F238E27FC236}">
                  <a16:creationId xmlns:a16="http://schemas.microsoft.com/office/drawing/2014/main" id="{8B80326E-0786-7ABC-37D3-D71B83D395D9}"/>
                </a:ext>
              </a:extLst>
            </p:cNvPr>
            <p:cNvCxnSpPr>
              <a:stCxn id="6" idx="3"/>
              <a:endCxn id="8" idx="1"/>
            </p:cNvCxnSpPr>
            <p:nvPr/>
          </p:nvCxnSpPr>
          <p:spPr>
            <a:xfrm>
              <a:off x="5274733" y="2071511"/>
              <a:ext cx="397933" cy="0"/>
            </a:xfrm>
            <a:prstGeom prst="straightConnector1">
              <a:avLst/>
            </a:prstGeom>
            <a:ln>
              <a:solidFill>
                <a:srgbClr val="002060"/>
              </a:solidFill>
              <a:tailEnd type="triangle"/>
            </a:ln>
            <a:scene3d>
              <a:camera prst="orthographicFront"/>
              <a:lightRig rig="threePt" dir="t"/>
            </a:scene3d>
            <a:sp3d>
              <a:bevelT w="139700" prst="cross"/>
            </a:sp3d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接箭头连接符 26">
              <a:extLst>
                <a:ext uri="{FF2B5EF4-FFF2-40B4-BE49-F238E27FC236}">
                  <a16:creationId xmlns:a16="http://schemas.microsoft.com/office/drawing/2014/main" id="{2E67867C-4729-331D-48BB-E50DA09B45A1}"/>
                </a:ext>
              </a:extLst>
            </p:cNvPr>
            <p:cNvCxnSpPr>
              <a:stCxn id="8" idx="3"/>
              <a:endCxn id="7" idx="1"/>
            </p:cNvCxnSpPr>
            <p:nvPr/>
          </p:nvCxnSpPr>
          <p:spPr>
            <a:xfrm>
              <a:off x="6699955" y="2071511"/>
              <a:ext cx="397933" cy="0"/>
            </a:xfrm>
            <a:prstGeom prst="straightConnector1">
              <a:avLst/>
            </a:prstGeom>
            <a:ln>
              <a:solidFill>
                <a:srgbClr val="002060"/>
              </a:solidFill>
              <a:tailEnd type="triangle"/>
            </a:ln>
            <a:scene3d>
              <a:camera prst="orthographicFront"/>
              <a:lightRig rig="threePt" dir="t"/>
            </a:scene3d>
            <a:sp3d>
              <a:bevelT w="139700" prst="cross"/>
            </a:sp3d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2E70245D-2B59-A813-0E43-07AAB4BB460E}"/>
                </a:ext>
              </a:extLst>
            </p:cNvPr>
            <p:cNvSpPr txBox="1"/>
            <p:nvPr/>
          </p:nvSpPr>
          <p:spPr>
            <a:xfrm>
              <a:off x="3911016" y="929948"/>
              <a:ext cx="1027289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r>
                <a:rPr lang="en-US" altLang="zh-CN" sz="1000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nsor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88FF1F0F-4400-85BB-93B6-82BE72B1ADC0}"/>
                </a:ext>
              </a:extLst>
            </p:cNvPr>
            <p:cNvSpPr txBox="1"/>
            <p:nvPr/>
          </p:nvSpPr>
          <p:spPr>
            <a:xfrm>
              <a:off x="7679265" y="891116"/>
              <a:ext cx="110631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r>
                <a:rPr lang="en-US" altLang="zh-CN" sz="1000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fector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9D2B3D91-0C65-C9AB-AC9E-DCCA227F2B0A}"/>
                </a:ext>
              </a:extLst>
            </p:cNvPr>
            <p:cNvSpPr txBox="1"/>
            <p:nvPr/>
          </p:nvSpPr>
          <p:spPr>
            <a:xfrm>
              <a:off x="7679265" y="2472629"/>
              <a:ext cx="119915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r>
                <a:rPr lang="en-US" altLang="zh-CN" sz="1000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in body 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580742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14</Words>
  <Application>Microsoft Office PowerPoint</Application>
  <PresentationFormat>宽屏</PresentationFormat>
  <Paragraphs>1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hink</dc:creator>
  <cp:lastModifiedBy>Think</cp:lastModifiedBy>
  <cp:revision>1</cp:revision>
  <dcterms:created xsi:type="dcterms:W3CDTF">2022-10-08T08:59:44Z</dcterms:created>
  <dcterms:modified xsi:type="dcterms:W3CDTF">2022-10-08T09:33:04Z</dcterms:modified>
</cp:coreProperties>
</file>